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F54638-B0DE-46FC-A4C4-7A3403CEC2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1726EE6-E548-4E97-9F6F-426A4CD67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EB7942-5503-4865-AFF4-63D683D0C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E6944B-98EC-4E64-9B39-C5C151888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3CD6E7-D644-4B3F-AA60-F908C0EC9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1697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851376-AC6D-42E7-91C3-868EFCCB3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F3F02A-E408-46B8-84DE-0D62616C5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8ED5A8-7A8C-4185-9458-9991AE44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D7CB57-1821-4A5B-96A0-0BE9F67D9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277D18-3D2E-46A0-8DE3-716398FD9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94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4A6A5FF-8EF2-4378-9059-0E9ACE4A5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44B112B-81CD-4C67-8C64-56BE5DE90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77ACF6-7DCE-4A7F-A69D-32AEC8F38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DCFE17-5D0E-46A0-AB92-FA7A940EE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99A74F-302B-472B-8DCA-0CE09DEEE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76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913BD7-9F3D-4180-A641-EC99B4894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A097BA-3799-46BD-95E6-7AD2849933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9B341-E57F-4930-BC4D-795EA2061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A3C910-2319-4046-ACE7-A9D6254B0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E748E2-0DF9-4F7F-9243-0DEA3826E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7AF777-C9AC-4997-AA6C-9C3CDEB09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364F93-2EA2-4E78-A1FF-E4BFAD77B7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E24DCD5-7010-4BD3-939D-83AC60E29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F4C4AB-B3D8-4606-AE46-10CE0846B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4B8AB8F-0731-4D41-A6CB-5ADBAF7FE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647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9A6B2-EE2F-4249-95AA-DD78206CC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085B3C-A126-429B-BEB0-D7EF747E2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E95E5B6-E1D4-46C8-807E-EE5165035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A27B35B-0452-4BCA-9A8F-EF70AFA18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6FA2867-B804-4DC6-9EFB-EACBEF7DB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66DCA5-A41D-475F-8AA3-CA53C2358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7559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608F4B-3B4B-4224-9281-194A6AECE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743B62E-C417-45CA-8C1A-553915454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54FAF4B-E630-4938-AE62-91E906E1C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2237940-714E-4424-B4BB-D90E985F0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97F3021-8F9B-4F3C-A7BF-0D4348E09B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3917500-1275-4C41-BC77-CC554E3D4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6BB5974-4917-4A77-B485-2BC0B850A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4B0BADA-BA75-411A-9F29-4797F8CFD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7829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CDFE86-77FB-491A-B64E-D8293BC09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169DE58-B09C-4022-986E-A95B50C0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117D388-F3CB-4243-9F86-6A7AF7D3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024DAA-0E21-4998-B14F-FED43066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935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A637DC5-532B-4F00-9DD6-851344C6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65FF5F-AFE7-4D14-8F61-87A922417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01A8FA2-A3DE-471D-B007-DB3FCAF87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88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D56441-940D-41A1-B5DD-E390CC1F6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EC35651-B2D7-4003-A675-78B0C849A9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6779868-F07A-4FDD-AC42-0DCF15914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7F9EEAE-9EEA-4131-BE5D-BB57CC772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029FD8-964E-4D70-800E-07114247F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D99B1E-8FA0-4BAF-807A-BB223DB8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24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D78DBC-C5A0-46CC-8900-C270D1A42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FC47DAE-A316-4683-BE3B-5462A9C93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112AB42-26EA-4886-BFF4-C1E2A005C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2440890-27CC-4A8B-8E8E-58FEB251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2CD48AA-C815-4525-8532-3D14683FE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72E2D61-0702-4C65-BA8E-D192A7A1F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756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87FADD8-8121-4B24-8918-54BB501C4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D58F6F3-F6B6-43EA-B863-AF4D76DBE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B2633B-4AD7-4356-96E7-049E24F55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AC0011-A8C4-47AC-AD00-ABFE4FF064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31B647-A2D7-4AEA-9BC3-EB0C399141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95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C29696EF-2AF9-441F-A06A-6663D718082A}"/>
              </a:ext>
            </a:extLst>
          </p:cNvPr>
          <p:cNvSpPr txBox="1"/>
          <p:nvPr/>
        </p:nvSpPr>
        <p:spPr>
          <a:xfrm>
            <a:off x="629175" y="3909270"/>
            <a:ext cx="3401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Tabelle 1 </a:t>
            </a:r>
            <a:r>
              <a:rPr lang="de-DE" dirty="0" err="1"/>
              <a:t>supplementary</a:t>
            </a:r>
            <a:r>
              <a:rPr lang="de-DE" dirty="0"/>
              <a:t> material</a:t>
            </a: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0AAEC7E5-5BB2-4496-8FBD-BA8ADBB6AF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6607293"/>
              </p:ext>
            </p:extLst>
          </p:nvPr>
        </p:nvGraphicFramePr>
        <p:xfrm>
          <a:off x="629175" y="912613"/>
          <a:ext cx="3733100" cy="14698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8623">
                  <a:extLst>
                    <a:ext uri="{9D8B030D-6E8A-4147-A177-3AD203B41FA5}">
                      <a16:colId xmlns:a16="http://schemas.microsoft.com/office/drawing/2014/main" val="3325770058"/>
                    </a:ext>
                  </a:extLst>
                </a:gridCol>
                <a:gridCol w="1367406">
                  <a:extLst>
                    <a:ext uri="{9D8B030D-6E8A-4147-A177-3AD203B41FA5}">
                      <a16:colId xmlns:a16="http://schemas.microsoft.com/office/drawing/2014/main" val="3160373919"/>
                    </a:ext>
                  </a:extLst>
                </a:gridCol>
                <a:gridCol w="1317071">
                  <a:extLst>
                    <a:ext uri="{9D8B030D-6E8A-4147-A177-3AD203B41FA5}">
                      <a16:colId xmlns:a16="http://schemas.microsoft.com/office/drawing/2014/main" val="2932977520"/>
                    </a:ext>
                  </a:extLst>
                </a:gridCol>
              </a:tblGrid>
              <a:tr h="293972">
                <a:tc>
                  <a:txBody>
                    <a:bodyPr/>
                    <a:lstStyle/>
                    <a:p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CBCT </a:t>
                      </a:r>
                      <a:r>
                        <a:rPr lang="de-DE" sz="1200" dirty="0" err="1"/>
                        <a:t>righ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breast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CBCT </a:t>
                      </a:r>
                      <a:r>
                        <a:rPr lang="de-DE" sz="1200" dirty="0" err="1"/>
                        <a:t>left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breast</a:t>
                      </a:r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305626"/>
                  </a:ext>
                </a:extLst>
              </a:tr>
              <a:tr h="293972">
                <a:tc>
                  <a:txBody>
                    <a:bodyPr/>
                    <a:lstStyle/>
                    <a:p>
                      <a:r>
                        <a:rPr lang="de-DE" sz="1200" dirty="0" err="1"/>
                        <a:t>Collimator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S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/>
                        <a:t>S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2670457"/>
                  </a:ext>
                </a:extLst>
              </a:tr>
              <a:tr h="293972">
                <a:tc>
                  <a:txBody>
                    <a:bodyPr/>
                    <a:lstStyle/>
                    <a:p>
                      <a:r>
                        <a:rPr lang="de-DE" sz="1200" dirty="0"/>
                        <a:t>Filt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F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F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470299"/>
                  </a:ext>
                </a:extLst>
              </a:tr>
              <a:tr h="293972">
                <a:tc>
                  <a:txBody>
                    <a:bodyPr/>
                    <a:lstStyle/>
                    <a:p>
                      <a:r>
                        <a:rPr lang="de-DE" sz="1200" dirty="0" err="1"/>
                        <a:t>KVpeak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1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1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94066417"/>
                  </a:ext>
                </a:extLst>
              </a:tr>
              <a:tr h="293972">
                <a:tc>
                  <a:txBody>
                    <a:bodyPr/>
                    <a:lstStyle/>
                    <a:p>
                      <a:r>
                        <a:rPr lang="de-DE" sz="1200" dirty="0" err="1"/>
                        <a:t>mA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585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200" dirty="0"/>
                        <a:t>585.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34916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82900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Breitbild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iara De-Colle</dc:creator>
  <cp:lastModifiedBy>Sabine König</cp:lastModifiedBy>
  <cp:revision>21</cp:revision>
  <dcterms:created xsi:type="dcterms:W3CDTF">2021-07-13T16:18:21Z</dcterms:created>
  <dcterms:modified xsi:type="dcterms:W3CDTF">2022-03-14T10:03:22Z</dcterms:modified>
</cp:coreProperties>
</file>